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7" d="100"/>
          <a:sy n="67" d="100"/>
        </p:scale>
        <p:origin x="60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E48B5A-C0DD-D2D9-9E0A-44583C4823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037B539-B9B6-0A0D-E9E7-71AD69FD71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E10704-90D7-66FD-B18C-F51123BC7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CFD704-E219-2317-C1F1-F9B9D84837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E1DE23-A6F9-689C-A692-D190DCC03A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5063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3CB477-799E-3C30-85DE-FA51172F4E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51E965A-AE89-985F-0D13-60D33CDDD6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D70FA0-5E80-391E-E1CD-190FEC704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730725-294B-A2B2-E144-47E4A43BA5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17034D-371A-23BC-30E4-4DC92CBD66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31787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D1CA92-B682-E104-3C12-73A4700E9BC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FC0D26-E86B-2265-F6C6-08D05D30BD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ADBDB2-66D1-700F-A1B7-B57580E633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9660DD-A043-B226-EF9A-8E4775BA46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59F770-7F33-F496-D639-BF6385981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951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59ABC6-5EBB-9C4E-8484-3ED270711C2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DC2F48C-F45C-0746-A029-68D8CEF6E74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A592EF-6FF1-AAF6-DE31-2D035EE8BA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24325D7-8E10-A55F-1AE6-E16432B7F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9122BE-38C6-C059-83A9-72B484B101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2977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9F53A-A8A2-4EAF-0B21-88CB9DBCC2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5EDA5F-4B99-F5E5-65E3-17D1A8E757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A36012-524D-D24B-92B0-DD6BDC4CC5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0DDDFA-C4D9-B22C-52EF-D97402C563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0103E4-6B39-ABB3-66AC-BE2536A530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6297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A49641-539A-95E7-0BA2-BE59D37B68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816A7A-2A10-2073-6DD4-1B6EA0F6CCA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8BF429-0C10-DEDA-109D-7F08F70396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B6EFEE-94F2-305B-1314-6B1A16ABB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BB1013-3B38-7256-90F8-28E36CF4F3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BA53B90-30AB-27F5-8203-DF23CF34E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08162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ED7AB3-2484-D360-9FE1-C72135CEA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A4EFC-F42F-3A21-9301-A91E2C3BCD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4603073-63FC-7489-4CBB-FC768839FB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0C465B-F8C9-34CE-B7C3-2063E7217D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E62C831-0EE8-92E7-0C5B-27D4B5E1FE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1E8256-ED61-20AB-4BA1-C1DD442E3A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D629F54-740F-D837-1EF3-276D7D9587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721B98E-11BD-12F6-77AE-F46C89798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65482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0FEF4-50F8-8453-27D9-A5FBB3C3A5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742F247-19EE-3D22-E67F-B62126E35D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20BEC08-9657-465A-7EB0-AF54F3FE33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BC6187-D646-F43A-FA92-D5AFDC77E5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626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BC9D19A-1AF4-690F-3DA6-9C67AE1019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23A16A-C5B3-EE52-5631-6EC1FEE3D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F6E2E3-2292-253B-E420-AE6F66B95B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94136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2AAB924-D82A-DC38-82A6-BEC7504958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57FB0A-05FA-E772-2E45-9C827FDDAA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1AB03D-D8B1-BE62-18F6-40A95F0C35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8416C8E-8265-6CC2-776A-84E1983A77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D52F79-5B2D-94AE-2B05-0FA33D1F31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FE72BB-2586-18E2-A710-F5343CAC2D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9750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8CE23-510B-D614-53C8-1EEC75453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BA4CD56-B29B-B0EF-31C0-936875BC82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66802B9-43E2-B741-C77C-E649C3E7EC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05D8AC-9447-CA66-47A2-E58160050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E9711AC-651B-F1DB-CFE4-887ACCD0F0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0D24F1B-B10B-AD99-D121-520F7A589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5982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BE975CE-4C03-87A3-2614-25E553CDC8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C531ED-B7B7-FB33-0092-AE546E3488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3945F4-421C-5500-236D-F9D9E8457B4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D4569C-1CBD-4387-94B3-939E9F2DC6C8}" type="datetimeFigureOut">
              <a:rPr lang="en-GB" smtClean="0"/>
              <a:t>02/07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DDDFC4-0497-97F3-7FF2-A2194D0F21C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BA7EC-A93C-E971-20C4-479EBD365F9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7DDF7E-000D-4A59-857A-DF60091B047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8263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>
            <a:extLst>
              <a:ext uri="{FF2B5EF4-FFF2-40B4-BE49-F238E27FC236}">
                <a16:creationId xmlns:a16="http://schemas.microsoft.com/office/drawing/2014/main" id="{EFD9EC9E-E583-9E9E-CA18-D114052B2580}"/>
              </a:ext>
            </a:extLst>
          </p:cNvPr>
          <p:cNvGrpSpPr/>
          <p:nvPr/>
        </p:nvGrpSpPr>
        <p:grpSpPr>
          <a:xfrm>
            <a:off x="3269734" y="1997075"/>
            <a:ext cx="5474216" cy="2778125"/>
            <a:chOff x="3269734" y="1997075"/>
            <a:chExt cx="5474216" cy="2778125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BB59546-2767-CCCF-A1BD-77861E20211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233" b="2994"/>
            <a:stretch/>
          </p:blipFill>
          <p:spPr>
            <a:xfrm>
              <a:off x="3324225" y="1997075"/>
              <a:ext cx="5419725" cy="2778125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9DE25D26-ECED-66EA-96CB-20B7A5AA6CDA}"/>
                </a:ext>
              </a:extLst>
            </p:cNvPr>
            <p:cNvSpPr txBox="1"/>
            <p:nvPr/>
          </p:nvSpPr>
          <p:spPr>
            <a:xfrm rot="16200000">
              <a:off x="2959100" y="3201471"/>
              <a:ext cx="990600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GB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B71E604F-1D4C-7F40-7B23-8AC318817647}"/>
                </a:ext>
              </a:extLst>
            </p:cNvPr>
            <p:cNvSpPr txBox="1"/>
            <p:nvPr/>
          </p:nvSpPr>
          <p:spPr>
            <a:xfrm rot="16200000">
              <a:off x="3077587" y="3137474"/>
              <a:ext cx="86260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/>
                <a:t>B score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04803BC-049A-0C69-B2C8-07B5DFACAAFA}"/>
                </a:ext>
              </a:extLst>
            </p:cNvPr>
            <p:cNvSpPr/>
            <p:nvPr/>
          </p:nvSpPr>
          <p:spPr>
            <a:xfrm>
              <a:off x="4559300" y="1997075"/>
              <a:ext cx="2946400" cy="41592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925449F5-F374-934A-6231-733B209FE0BD}"/>
                </a:ext>
              </a:extLst>
            </p:cNvPr>
            <p:cNvSpPr txBox="1"/>
            <p:nvPr/>
          </p:nvSpPr>
          <p:spPr>
            <a:xfrm>
              <a:off x="4045793" y="2099324"/>
              <a:ext cx="36703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Glucose Median and IQRs of B scores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62F9884D-0D70-2F41-86A5-B602841E7195}"/>
                </a:ext>
              </a:extLst>
            </p:cNvPr>
            <p:cNvSpPr/>
            <p:nvPr/>
          </p:nvSpPr>
          <p:spPr>
            <a:xfrm>
              <a:off x="4108450" y="4438651"/>
              <a:ext cx="4000500" cy="3175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BBC4C150-DC48-C064-D941-C76C29F3B603}"/>
              </a:ext>
            </a:extLst>
          </p:cNvPr>
          <p:cNvSpPr txBox="1"/>
          <p:nvPr/>
        </p:nvSpPr>
        <p:spPr>
          <a:xfrm rot="16200000">
            <a:off x="4086220" y="4352932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914F998-64D9-73C4-E9FB-D0C6E70F9CA3}"/>
              </a:ext>
            </a:extLst>
          </p:cNvPr>
          <p:cNvSpPr txBox="1"/>
          <p:nvPr/>
        </p:nvSpPr>
        <p:spPr>
          <a:xfrm rot="16200000">
            <a:off x="4282512" y="4429132"/>
            <a:ext cx="3914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JJ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E80A757-8DDF-02CE-F54A-22DB79085AC0}"/>
              </a:ext>
            </a:extLst>
          </p:cNvPr>
          <p:cNvSpPr txBox="1"/>
          <p:nvPr/>
        </p:nvSpPr>
        <p:spPr>
          <a:xfrm rot="16200000">
            <a:off x="4523135" y="440373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1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C87D407-62E3-5CA4-6D35-49CDA045F09A}"/>
              </a:ext>
            </a:extLst>
          </p:cNvPr>
          <p:cNvSpPr txBox="1"/>
          <p:nvPr/>
        </p:nvSpPr>
        <p:spPr>
          <a:xfrm rot="16200000">
            <a:off x="4658472" y="4467232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1BK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06D399B-5E8C-45E4-1A59-59D112D582C9}"/>
              </a:ext>
            </a:extLst>
          </p:cNvPr>
          <p:cNvSpPr txBox="1"/>
          <p:nvPr/>
        </p:nvSpPr>
        <p:spPr>
          <a:xfrm rot="16200000">
            <a:off x="4925746" y="4473582"/>
            <a:ext cx="5358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1Y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F26B4ED-2CC9-2EFA-9F49-E66F22BBA8D8}"/>
              </a:ext>
            </a:extLst>
          </p:cNvPr>
          <p:cNvSpPr txBox="1"/>
          <p:nvPr/>
        </p:nvSpPr>
        <p:spPr>
          <a:xfrm rot="16200000">
            <a:off x="5247035" y="439738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A55B72A3-318D-3025-5F9B-F2BE35B31949}"/>
              </a:ext>
            </a:extLst>
          </p:cNvPr>
          <p:cNvSpPr txBox="1"/>
          <p:nvPr/>
        </p:nvSpPr>
        <p:spPr>
          <a:xfrm rot="16200000">
            <a:off x="5374646" y="4486282"/>
            <a:ext cx="5693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AB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C590E71-6BB3-4EED-3B7B-F3959B7F4A8E}"/>
              </a:ext>
            </a:extLst>
          </p:cNvPr>
          <p:cNvSpPr txBox="1"/>
          <p:nvPr/>
        </p:nvSpPr>
        <p:spPr>
          <a:xfrm rot="16200000">
            <a:off x="5617203" y="4492632"/>
            <a:ext cx="58419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AU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3CB3518-C7BA-BD18-FFAD-6F9A6CF37774}"/>
              </a:ext>
            </a:extLst>
          </p:cNvPr>
          <p:cNvSpPr txBox="1"/>
          <p:nvPr/>
        </p:nvSpPr>
        <p:spPr>
          <a:xfrm rot="16200000">
            <a:off x="5868659" y="4486282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OL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559DF9CD-6005-EDC5-3942-4EA803090ED9}"/>
              </a:ext>
            </a:extLst>
          </p:cNvPr>
          <p:cNvSpPr txBox="1"/>
          <p:nvPr/>
        </p:nvSpPr>
        <p:spPr>
          <a:xfrm rot="16200000">
            <a:off x="6112819" y="4492631"/>
            <a:ext cx="5581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BK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C7B0DAD-CE05-69F4-2B4B-6D0DD0403992}"/>
              </a:ext>
            </a:extLst>
          </p:cNvPr>
          <p:cNvSpPr txBox="1"/>
          <p:nvPr/>
        </p:nvSpPr>
        <p:spPr>
          <a:xfrm rot="16200000">
            <a:off x="6359351" y="4486598"/>
            <a:ext cx="556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B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4DCAC92-1E62-5057-EF60-9BAF820B3F69}"/>
              </a:ext>
            </a:extLst>
          </p:cNvPr>
          <p:cNvSpPr txBox="1"/>
          <p:nvPr/>
        </p:nvSpPr>
        <p:spPr>
          <a:xfrm rot="16200000">
            <a:off x="6571964" y="4485233"/>
            <a:ext cx="5565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R0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BF41BA1-6DD6-57B4-3B3D-DE118C59C84C}"/>
              </a:ext>
            </a:extLst>
          </p:cNvPr>
          <p:cNvSpPr txBox="1"/>
          <p:nvPr/>
        </p:nvSpPr>
        <p:spPr>
          <a:xfrm rot="16200000">
            <a:off x="6824783" y="4485233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T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6DFC44F-D814-C2BC-5714-E7E223EA6585}"/>
              </a:ext>
            </a:extLst>
          </p:cNvPr>
          <p:cNvSpPr txBox="1"/>
          <p:nvPr/>
        </p:nvSpPr>
        <p:spPr>
          <a:xfrm rot="16200000">
            <a:off x="7061803" y="4485232"/>
            <a:ext cx="55335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15B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960D3AE-A919-02F3-86BC-A8A6E9974A59}"/>
              </a:ext>
            </a:extLst>
          </p:cNvPr>
          <p:cNvSpPr txBox="1"/>
          <p:nvPr/>
        </p:nvSpPr>
        <p:spPr>
          <a:xfrm rot="16200000">
            <a:off x="7424185" y="4350786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4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5EAEB4C-90FD-5AC9-8F31-88FF64903CFB}"/>
              </a:ext>
            </a:extLst>
          </p:cNvPr>
          <p:cNvSpPr txBox="1"/>
          <p:nvPr/>
        </p:nvSpPr>
        <p:spPr>
          <a:xfrm rot="16200000">
            <a:off x="7507972" y="4433800"/>
            <a:ext cx="4924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4BO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493A2408-1D7E-D3AB-941E-40DF6B3157B4}"/>
              </a:ext>
            </a:extLst>
          </p:cNvPr>
          <p:cNvSpPr txBox="1"/>
          <p:nvPr/>
        </p:nvSpPr>
        <p:spPr>
          <a:xfrm rot="16200000">
            <a:off x="7792055" y="4427450"/>
            <a:ext cx="45236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4TE</a:t>
            </a:r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98772FCE-DEB2-D5D3-E321-2960C193C8D7}"/>
              </a:ext>
            </a:extLst>
          </p:cNvPr>
          <p:cNvSpPr/>
          <p:nvPr/>
        </p:nvSpPr>
        <p:spPr>
          <a:xfrm rot="16200000">
            <a:off x="7933352" y="2475983"/>
            <a:ext cx="745928" cy="36933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DAA4416-B63C-16BD-63E1-7EE9293B4724}"/>
              </a:ext>
            </a:extLst>
          </p:cNvPr>
          <p:cNvSpPr/>
          <p:nvPr/>
        </p:nvSpPr>
        <p:spPr>
          <a:xfrm>
            <a:off x="8490983" y="2241550"/>
            <a:ext cx="224392" cy="6492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C8F3C0B-B501-80EB-59D7-0D129129DF3B}"/>
              </a:ext>
            </a:extLst>
          </p:cNvPr>
          <p:cNvSpPr txBox="1"/>
          <p:nvPr/>
        </p:nvSpPr>
        <p:spPr>
          <a:xfrm rot="16200000">
            <a:off x="8039238" y="2570009"/>
            <a:ext cx="3722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All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DA676FB-F89F-CE99-CA7A-4C1F9D5014F3}"/>
              </a:ext>
            </a:extLst>
          </p:cNvPr>
          <p:cNvSpPr txBox="1"/>
          <p:nvPr/>
        </p:nvSpPr>
        <p:spPr>
          <a:xfrm rot="16200000">
            <a:off x="8062735" y="2451169"/>
            <a:ext cx="6418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Group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A39D15A-64E5-85F9-9D6C-CAE3485DF2BB}"/>
              </a:ext>
            </a:extLst>
          </p:cNvPr>
          <p:cNvSpPr txBox="1"/>
          <p:nvPr/>
        </p:nvSpPr>
        <p:spPr>
          <a:xfrm rot="16200000">
            <a:off x="8214501" y="2412303"/>
            <a:ext cx="7720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dirty="0"/>
              <a:t>Metho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0493041-F3AF-44B6-BFF1-434C1F418F68}"/>
              </a:ext>
            </a:extLst>
          </p:cNvPr>
          <p:cNvSpPr txBox="1"/>
          <p:nvPr/>
        </p:nvSpPr>
        <p:spPr>
          <a:xfrm>
            <a:off x="207233" y="53397"/>
            <a:ext cx="11860941" cy="966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</a:t>
            </a:r>
            <a:r>
              <a:rPr lang="en-GB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Results from UK National External Quality Assurance (NEQAS) showing that </a:t>
            </a:r>
            <a:r>
              <a:rPr lang="en-GB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re is no systematic bias in the Dimension method when compared to the national consensus values. The Dimension method used for enhanced processing in this study is coded as 15BE. </a:t>
            </a:r>
            <a:endParaRPr lang="en-GB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94098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77</Words>
  <Application>Microsoft Office PowerPoint</Application>
  <PresentationFormat>Widescreen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a Kusinski</dc:creator>
  <cp:lastModifiedBy>Laura Kusinski</cp:lastModifiedBy>
  <cp:revision>8</cp:revision>
  <dcterms:created xsi:type="dcterms:W3CDTF">2024-05-02T10:38:39Z</dcterms:created>
  <dcterms:modified xsi:type="dcterms:W3CDTF">2024-07-02T13:53:06Z</dcterms:modified>
</cp:coreProperties>
</file>